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8"/>
  </p:notesMasterIdLst>
  <p:sldIdLst>
    <p:sldId id="268" r:id="rId2"/>
    <p:sldId id="263" r:id="rId3"/>
    <p:sldId id="264" r:id="rId4"/>
    <p:sldId id="259" r:id="rId5"/>
    <p:sldId id="267" r:id="rId6"/>
    <p:sldId id="266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404" autoAdjust="0"/>
    <p:restoredTop sz="94660"/>
  </p:normalViewPr>
  <p:slideViewPr>
    <p:cSldViewPr snapToGrid="0">
      <p:cViewPr>
        <p:scale>
          <a:sx n="66" d="100"/>
          <a:sy n="66" d="100"/>
        </p:scale>
        <p:origin x="1992" y="-5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E616C2E-886E-4A1C-AD06-6D4EBC93E835}" type="datetimeFigureOut">
              <a:rPr lang="zh-CN" altLang="en-US" smtClean="0"/>
              <a:t>2022/3/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6BEE5D3-79B5-4BDF-AF0C-2F1FBD61D86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62608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0B5D74F-7C32-4810-BF24-EFFDE1FEAFFA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9055807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C4A6D5-AFFA-43F6-94AE-A7538922A4AB}" type="datetimeFigureOut">
              <a:rPr lang="zh-CN" altLang="en-US" smtClean="0"/>
              <a:t>2022/3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5E12C-595D-4811-AA7F-F9AB3E47593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600118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C4A6D5-AFFA-43F6-94AE-A7538922A4AB}" type="datetimeFigureOut">
              <a:rPr lang="zh-CN" altLang="en-US" smtClean="0"/>
              <a:t>2022/3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5E12C-595D-4811-AA7F-F9AB3E47593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70053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C4A6D5-AFFA-43F6-94AE-A7538922A4AB}" type="datetimeFigureOut">
              <a:rPr lang="zh-CN" altLang="en-US" smtClean="0"/>
              <a:t>2022/3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5E12C-595D-4811-AA7F-F9AB3E47593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150611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C4A6D5-AFFA-43F6-94AE-A7538922A4AB}" type="datetimeFigureOut">
              <a:rPr lang="zh-CN" altLang="en-US" smtClean="0"/>
              <a:t>2022/3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5E12C-595D-4811-AA7F-F9AB3E47593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310917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C4A6D5-AFFA-43F6-94AE-A7538922A4AB}" type="datetimeFigureOut">
              <a:rPr lang="zh-CN" altLang="en-US" smtClean="0"/>
              <a:t>2022/3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5E12C-595D-4811-AA7F-F9AB3E47593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643715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C4A6D5-AFFA-43F6-94AE-A7538922A4AB}" type="datetimeFigureOut">
              <a:rPr lang="zh-CN" altLang="en-US" smtClean="0"/>
              <a:t>2022/3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5E12C-595D-4811-AA7F-F9AB3E47593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23585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C4A6D5-AFFA-43F6-94AE-A7538922A4AB}" type="datetimeFigureOut">
              <a:rPr lang="zh-CN" altLang="en-US" smtClean="0"/>
              <a:t>2022/3/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5E12C-595D-4811-AA7F-F9AB3E47593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086165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C4A6D5-AFFA-43F6-94AE-A7538922A4AB}" type="datetimeFigureOut">
              <a:rPr lang="zh-CN" altLang="en-US" smtClean="0"/>
              <a:t>2022/3/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5E12C-595D-4811-AA7F-F9AB3E47593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248502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C4A6D5-AFFA-43F6-94AE-A7538922A4AB}" type="datetimeFigureOut">
              <a:rPr lang="zh-CN" altLang="en-US" smtClean="0"/>
              <a:t>2022/3/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5E12C-595D-4811-AA7F-F9AB3E47593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231427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C4A6D5-AFFA-43F6-94AE-A7538922A4AB}" type="datetimeFigureOut">
              <a:rPr lang="zh-CN" altLang="en-US" smtClean="0"/>
              <a:t>2022/3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5E12C-595D-4811-AA7F-F9AB3E47593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160201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C4A6D5-AFFA-43F6-94AE-A7538922A4AB}" type="datetimeFigureOut">
              <a:rPr lang="zh-CN" altLang="en-US" smtClean="0"/>
              <a:t>2022/3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5E12C-595D-4811-AA7F-F9AB3E47593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407088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C4A6D5-AFFA-43F6-94AE-A7538922A4AB}" type="datetimeFigureOut">
              <a:rPr lang="zh-CN" altLang="en-US" smtClean="0"/>
              <a:t>2022/3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E5E12C-595D-4811-AA7F-F9AB3E47593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568752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E468BE19-269B-49DF-B8B3-EEB2013ABBE7}"/>
              </a:ext>
            </a:extLst>
          </p:cNvPr>
          <p:cNvSpPr txBox="1"/>
          <p:nvPr/>
        </p:nvSpPr>
        <p:spPr>
          <a:xfrm>
            <a:off x="0" y="8645424"/>
            <a:ext cx="6857999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l Figure S1. Venn diagram representing the overlap of the identified proteins in the three biological repeats.</a:t>
            </a:r>
            <a:endParaRPr lang="zh-CN" altLang="zh-CN" sz="1200" kern="10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6BFE4154-7F80-4199-8ADE-C900668E8D6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8644"/>
          <a:stretch/>
        </p:blipFill>
        <p:spPr>
          <a:xfrm>
            <a:off x="1047750" y="2530168"/>
            <a:ext cx="4762500" cy="40617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066863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08141D05-DB90-43C7-AC75-DC6BB9AF5215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1759"/>
          <a:stretch/>
        </p:blipFill>
        <p:spPr>
          <a:xfrm>
            <a:off x="597404" y="2444802"/>
            <a:ext cx="5927351" cy="5016396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D070CEB3-5B66-44F9-9651-B95EB41C121E}"/>
              </a:ext>
            </a:extLst>
          </p:cNvPr>
          <p:cNvSpPr txBox="1"/>
          <p:nvPr/>
        </p:nvSpPr>
        <p:spPr>
          <a:xfrm>
            <a:off x="0" y="8645424"/>
            <a:ext cx="6857999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l Figure S2. Heatmap and hierarchical clustering of DEPs. The color represents relative protein content, Each  treatment time</a:t>
            </a:r>
            <a:r>
              <a:rPr lang="zh-CN" altLang="en-US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0h and 24h) has three biological repeats.</a:t>
            </a:r>
            <a:endParaRPr lang="zh-CN" altLang="zh-CN" sz="1200" kern="10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938802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B2F10190-9829-4D62-98EF-39580A54F5D1}"/>
              </a:ext>
            </a:extLst>
          </p:cNvPr>
          <p:cNvSpPr txBox="1"/>
          <p:nvPr/>
        </p:nvSpPr>
        <p:spPr>
          <a:xfrm>
            <a:off x="0" y="9257440"/>
            <a:ext cx="6857999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l Figure S3. The function of enriched DEPs in phagosome and endocytosis pathways by KEGG database. The DEPs are indicated in red.</a:t>
            </a:r>
            <a:endParaRPr lang="zh-CN" altLang="zh-CN" sz="1200" kern="10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AB6B8A94-E823-4642-BD21-0A68F6E7196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1817" y="4953000"/>
            <a:ext cx="5274365" cy="3745837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12D97B9B-89C7-4E36-A034-53CB81D31ED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8495" y="311936"/>
            <a:ext cx="5277687" cy="39229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7313429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877FBE80-D0BB-4E1D-92CE-74C850F1C828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1176431" y="2564357"/>
            <a:ext cx="4505139" cy="3490395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31E53861-90AF-4889-9B84-9A2FF6AC02CB}"/>
              </a:ext>
            </a:extLst>
          </p:cNvPr>
          <p:cNvSpPr txBox="1"/>
          <p:nvPr/>
        </p:nvSpPr>
        <p:spPr>
          <a:xfrm>
            <a:off x="0" y="8080281"/>
            <a:ext cx="68580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l Figure S4. Pathways that changed in biotic stress response after </a:t>
            </a:r>
            <a:r>
              <a:rPr lang="en-US" altLang="zh-CN" sz="1200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. </a:t>
            </a:r>
            <a:r>
              <a:rPr lang="en-US" altLang="zh-CN" sz="1200" i="1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ryzae</a:t>
            </a:r>
            <a:r>
              <a:rPr lang="en-US" altLang="zh-CN" sz="1200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nfection assayed in </a:t>
            </a:r>
            <a:r>
              <a:rPr lang="en-US" altLang="zh-CN" sz="1200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apMan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Red, up-regulated DEPs; blue, down-regulated DEPs. </a:t>
            </a:r>
          </a:p>
        </p:txBody>
      </p:sp>
    </p:spTree>
    <p:extLst>
      <p:ext uri="{BB962C8B-B14F-4D97-AF65-F5344CB8AC3E}">
        <p14:creationId xmlns:p14="http://schemas.microsoft.com/office/powerpoint/2010/main" val="79518945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31E53861-90AF-4889-9B84-9A2FF6AC02CB}"/>
              </a:ext>
            </a:extLst>
          </p:cNvPr>
          <p:cNvSpPr txBox="1"/>
          <p:nvPr/>
        </p:nvSpPr>
        <p:spPr>
          <a:xfrm>
            <a:off x="0" y="7864582"/>
            <a:ext cx="6858000" cy="15696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l Figure S5. The identification of 16 DEPs from transcriptional level after </a:t>
            </a:r>
            <a:r>
              <a:rPr lang="en-US" altLang="zh-CN" sz="1200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. </a:t>
            </a:r>
            <a:r>
              <a:rPr lang="en-US" altLang="zh-CN" sz="1200" i="1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ryzae</a:t>
            </a:r>
            <a:r>
              <a:rPr lang="en-US" altLang="zh-CN" sz="1200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nfection. The transcriptional expression patterns of 16 selected DEPs in </a:t>
            </a:r>
            <a:r>
              <a:rPr lang="en-US" altLang="zh-CN" sz="1200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eikezijing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(</a:t>
            </a:r>
            <a:r>
              <a:rPr lang="en-US" altLang="zh-CN" sz="1200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ei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) inoculated with the </a:t>
            </a:r>
            <a:r>
              <a:rPr lang="en-US" altLang="zh-CN" sz="1200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. </a:t>
            </a:r>
            <a:r>
              <a:rPr lang="en-US" altLang="zh-CN" sz="1200" i="1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ryzae</a:t>
            </a:r>
            <a:r>
              <a:rPr lang="en-US" altLang="zh-CN" sz="1200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train Hoku1 were investigated by RT-qPCR. DEPs were selected based on the fold change in proteomic analysis (1.1-1.2 or 0.8-0.909). The seedlings of </a:t>
            </a:r>
            <a:r>
              <a:rPr lang="en-US" altLang="zh-CN" sz="1200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ei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were collected after inoculation for 0h and 24h. The rice Actin gene was used as an internal control. The bar chart shows the average ± standard deviation (n=3). P &lt; 0.05 was shown as * and P &lt; 0.01 was shown as **. Red and green colored name represent up-regulated and down-regulated in proteomic analysis.</a:t>
            </a:r>
            <a:endParaRPr lang="zh-CN" altLang="zh-CN" sz="1200" kern="10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ctr"/>
            <a:endParaRPr lang="en-US" altLang="zh-CN" sz="1200" kern="10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3459350E-400D-4099-B50F-192959600D63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519" r="13704"/>
          <a:stretch/>
        </p:blipFill>
        <p:spPr>
          <a:xfrm>
            <a:off x="317500" y="1045911"/>
            <a:ext cx="6223000" cy="64128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4766240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31E53861-90AF-4889-9B84-9A2FF6AC02CB}"/>
              </a:ext>
            </a:extLst>
          </p:cNvPr>
          <p:cNvSpPr txBox="1"/>
          <p:nvPr/>
        </p:nvSpPr>
        <p:spPr>
          <a:xfrm>
            <a:off x="0" y="7413384"/>
            <a:ext cx="68580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l Figure S6.</a:t>
            </a:r>
            <a:r>
              <a:rPr lang="zh-CN" altLang="en-US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dentification</a:t>
            </a:r>
            <a:r>
              <a:rPr lang="zh-CN" altLang="en-US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f</a:t>
            </a:r>
            <a:r>
              <a:rPr lang="zh-CN" altLang="en-US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sNPSN13</a:t>
            </a:r>
            <a:r>
              <a:rPr lang="zh-CN" altLang="en-US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verexpression</a:t>
            </a:r>
            <a:r>
              <a:rPr lang="zh-CN" altLang="en-US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nd</a:t>
            </a:r>
            <a:r>
              <a:rPr lang="zh-CN" altLang="en-US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knockdown</a:t>
            </a:r>
            <a:r>
              <a:rPr lang="zh-CN" altLang="en-US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xpression</a:t>
            </a:r>
            <a:r>
              <a:rPr lang="zh-CN" altLang="en-US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ransgenic</a:t>
            </a:r>
            <a:r>
              <a:rPr lang="zh-CN" altLang="en-US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lants</a:t>
            </a:r>
            <a:r>
              <a:rPr lang="zh-CN" altLang="en-US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n</a:t>
            </a:r>
            <a:r>
              <a:rPr lang="zh-CN" altLang="en-US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PCR</a:t>
            </a:r>
            <a:r>
              <a:rPr lang="zh-CN" altLang="en-US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dentification of </a:t>
            </a:r>
            <a:r>
              <a:rPr lang="en-US" altLang="zh-CN" sz="1200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sNPSN13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transgenic lines and wild type </a:t>
            </a:r>
            <a:r>
              <a:rPr lang="en-US" altLang="zh-CN" sz="1200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by the genomic DNA templates, M: Trans2K Plus Ⅱ DNA marker.</a:t>
            </a: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7BEF5258-EC76-44C1-BB8D-A363C6D9DF1B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5228"/>
          <a:stretch/>
        </p:blipFill>
        <p:spPr>
          <a:xfrm>
            <a:off x="394636" y="3024139"/>
            <a:ext cx="5813659" cy="38577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773867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975</TotalTime>
  <Words>272</Words>
  <Application>Microsoft Office PowerPoint</Application>
  <PresentationFormat>A4 纸张(210x297 毫米)</PresentationFormat>
  <Paragraphs>7</Paragraphs>
  <Slides>6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2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.ZHAO</dc:creator>
  <cp:lastModifiedBy>赵 智</cp:lastModifiedBy>
  <cp:revision>50</cp:revision>
  <dcterms:created xsi:type="dcterms:W3CDTF">2020-11-13T02:24:28Z</dcterms:created>
  <dcterms:modified xsi:type="dcterms:W3CDTF">2022-03-02T13:00:42Z</dcterms:modified>
</cp:coreProperties>
</file>